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3575"/>
  </p:normalViewPr>
  <p:slideViewPr>
    <p:cSldViewPr snapToGrid="0">
      <p:cViewPr varScale="1">
        <p:scale>
          <a:sx n="66" d="100"/>
          <a:sy n="66" d="100"/>
        </p:scale>
        <p:origin x="960" y="192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58"/>
          <p:cNvPicPr>
            <a:picLocks noChangeAspect="1"/>
          </p:cNvPicPr>
          <p:nvPr/>
        </p:nvPicPr>
        <p:blipFill rotWithShape="1">
          <a:blip r:embed="rId2"/>
          <a:srcRect l="6890" b="12363"/>
          <a:stretch/>
        </p:blipFill>
        <p:spPr>
          <a:xfrm>
            <a:off x="2933975" y="1648605"/>
            <a:ext cx="3799926" cy="1896821"/>
          </a:xfrm>
          <a:prstGeom prst="rect">
            <a:avLst/>
          </a:prstGeom>
        </p:spPr>
      </p:pic>
      <p:sp>
        <p:nvSpPr>
          <p:cNvPr id="5" name="CuadroTexto 3"/>
          <p:cNvSpPr txBox="1"/>
          <p:nvPr/>
        </p:nvSpPr>
        <p:spPr>
          <a:xfrm>
            <a:off x="3410046" y="1176019"/>
            <a:ext cx="183604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C50 P[8]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H1 = 12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b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C50 P[8]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NB = 6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b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C50 P[8]</a:t>
            </a:r>
            <a:r>
              <a:rPr lang="en-US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W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vs H1 = 12.5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b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C50 P[8]</a:t>
            </a:r>
            <a:r>
              <a:rPr lang="en-US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W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NB = 15 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</a:p>
        </p:txBody>
      </p:sp>
      <p:sp>
        <p:nvSpPr>
          <p:cNvPr id="6" name="CuadroTexto 62"/>
          <p:cNvSpPr txBox="1"/>
          <p:nvPr/>
        </p:nvSpPr>
        <p:spPr>
          <a:xfrm>
            <a:off x="3394025" y="3573225"/>
            <a:ext cx="20553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P8* concentration in </a:t>
            </a:r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3"/>
          <p:cNvSpPr txBox="1"/>
          <p:nvPr/>
        </p:nvSpPr>
        <p:spPr>
          <a:xfrm rot="16200000">
            <a:off x="1846461" y="2411430"/>
            <a:ext cx="18758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Fluorescence units X 1000</a:t>
            </a:r>
          </a:p>
        </p:txBody>
      </p:sp>
      <p:sp>
        <p:nvSpPr>
          <p:cNvPr id="8" name="CuadroTexto 64"/>
          <p:cNvSpPr txBox="1"/>
          <p:nvPr/>
        </p:nvSpPr>
        <p:spPr>
          <a:xfrm>
            <a:off x="5976481" y="1795367"/>
            <a:ext cx="1092932" cy="7386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[P8]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H1 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[8]</a:t>
            </a:r>
            <a:r>
              <a:rPr lang="en-US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LNB</a:t>
            </a:r>
            <a:b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[8]</a:t>
            </a:r>
            <a:r>
              <a:rPr lang="en-US" sz="105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W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H1 </a:t>
            </a:r>
            <a:b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[8]</a:t>
            </a:r>
            <a:r>
              <a:rPr lang="en-US" sz="105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W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LNB </a:t>
            </a:r>
          </a:p>
        </p:txBody>
      </p:sp>
    </p:spTree>
    <p:extLst>
      <p:ext uri="{BB962C8B-B14F-4D97-AF65-F5344CB8AC3E}">
        <p14:creationId xmlns:p14="http://schemas.microsoft.com/office/powerpoint/2010/main" val="8597171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5</TotalTime>
  <Words>39</Words>
  <Application>Microsoft Macintosh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4</cp:revision>
  <dcterms:created xsi:type="dcterms:W3CDTF">2018-01-15T13:22:08Z</dcterms:created>
  <dcterms:modified xsi:type="dcterms:W3CDTF">2019-06-03T11:40:33Z</dcterms:modified>
</cp:coreProperties>
</file>